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5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44" d="100"/>
          <a:sy n="44" d="100"/>
        </p:scale>
        <p:origin x="30" y="4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BE022D-3D52-4095-8E48-91489167F9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153B7DF-F36A-475F-BCDC-CE363957AA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B01A33-2C62-44B6-939E-0B78C22A9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97A937-B773-4921-B8FA-2C4B41C95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A7D63A-4863-44AD-8BEC-9261D9C2B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139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4BCF2A-7BA9-4A82-A61F-D97F951609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7519B3F-B972-4154-8179-85ABE7C6F8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F5B836-593A-471D-A5BF-629F455EF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D7F6B8-1CFC-4F66-9F44-9C205F86B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53B759-3ABA-4AF3-AC2F-C9442DA1F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21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9127C04-5841-46B6-B147-823669321F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1408BD6-2034-438C-B927-9CF8E7F2EB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2E795B-805F-480C-8900-741074F61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33523B-700B-4834-A4C7-01DDE4101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8CD3BB-EFA7-451C-A1BA-4E8BD7C78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574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1468FC-6C95-42BA-A36B-E7A22A8476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52CAF62-4F11-4068-8311-3807EE9BAD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C6AB1E-DDE1-4EB4-BACB-8D7C94880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88A65B-7E5C-4E5B-8E13-42B458778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E202D2-00B2-40D8-8BFB-1F169E33B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103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D08094-9BB3-4D04-A479-49FD345994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64803A-CFCF-4825-8C58-23A9CDA4AD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7C775A-CF24-4EE8-86DC-1F70A55DB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34C029-903E-4333-A11A-B8571C8BF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7CA58B-0362-4E95-98B1-247E2E981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02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B533B4-7F55-4730-92E2-5BE13CC31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DBE9758-B11A-4BD1-91DF-0965BA726F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B16E257-E3E1-48C0-ADA4-7292F9AC4C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BA79B60-5CF4-44B6-90F4-EE3A383DB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419F56-F668-4CE5-9035-D807965E1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E1020CB-0A62-4452-AE5B-FED86FB69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221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BC9ACD-0AF1-40E6-A028-56629B82C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0E060B-9B5F-4C96-81E5-2DBD9E8EB6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D3075B-D276-4F27-A43E-B0F7BDA8AC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13AF687-889B-4814-8EA2-58C64B3B81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8BD9DD5-B7E1-44FF-BF33-0607189AA8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B5576A-3BCC-4AB9-AC63-1C05AFD6C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C021104-8444-47A0-A9E6-E05329F60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EF658BD-4337-4916-8433-47688687A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8912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499D19-1AD5-4CAF-B029-2A2DD04C74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977D596-876E-48CE-9D76-0C675BAA5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7DEA9DA-00A4-488E-B849-47C4E42AC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CBB7DC5-7751-490F-B0E5-97AB9778B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321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03FCB9A-E582-404D-91CC-C0F98990B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CAE2938-E1BC-4A63-9021-365047468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4AB11C2-50E7-45A6-B2C6-8991D0DE6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8792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D8D4C5-AE45-464F-8F9E-30FD231D5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07783D-9CDB-44C9-AA70-F64EE06CDE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76E8CB2-F5CE-4628-BDE1-9955C0366A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4D0F89-D70E-42DB-9CE4-BF347901D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987C09-390D-4389-9AB0-B12CF2AB1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E15E39-36C5-4861-B49D-B89493674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96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3FCCEA-0D38-4BC7-ACD9-075BDF51D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0BC17BC-EA36-4721-AE7F-8151AD01DD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913F0FB-4170-4EC4-B744-97C1731442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F9C1D6-674E-432F-9B57-EBA395C14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589968-00A5-4AD0-91CE-D552A5FF4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C2A629-958E-43C7-9DED-9CC017B0C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02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38A3AB0-0BB6-4B1D-ADEB-1F550A83B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9B71FC-B844-4F61-8F64-3161C7D3A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B08805-CA6A-44A7-8053-C0BA416983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F9A0C-125D-4E6D-AAED-01021F1E6D69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AC1F4F-26B1-4671-A504-912B18751A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542835-57C9-4044-BF97-476B10D883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56D22-295B-46D5-A859-6573A548A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5188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extBox 10">
            <a:extLst>
              <a:ext uri="{FF2B5EF4-FFF2-40B4-BE49-F238E27FC236}">
                <a16:creationId xmlns:a16="http://schemas.microsoft.com/office/drawing/2014/main" id="{52DB9B48-0FFC-4DF4-AD7B-F60743632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775" y="4763"/>
            <a:ext cx="17811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sp>
        <p:nvSpPr>
          <p:cNvPr id="7171" name="TextBox 10">
            <a:extLst>
              <a:ext uri="{FF2B5EF4-FFF2-40B4-BE49-F238E27FC236}">
                <a16:creationId xmlns:a16="http://schemas.microsoft.com/office/drawing/2014/main" id="{0F96C379-0CC7-4FEE-ADB4-54B666722F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688" y="1001713"/>
            <a:ext cx="3317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5F7822D7-67A0-4F17-BC67-B918285338A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18" t="63603" r="17953" b="18194"/>
          <a:stretch/>
        </p:blipFill>
        <p:spPr>
          <a:xfrm>
            <a:off x="5739880" y="480718"/>
            <a:ext cx="3168503" cy="1041990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1140F1A4-9006-4CE2-BDFB-3F4AA08A9F6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91" t="20255" r="30404" b="32519"/>
          <a:stretch/>
        </p:blipFill>
        <p:spPr>
          <a:xfrm>
            <a:off x="5651523" y="2461688"/>
            <a:ext cx="3229849" cy="2339163"/>
          </a:xfrm>
          <a:prstGeom prst="rect">
            <a:avLst/>
          </a:prstGeom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A11F7276-07F1-48F4-A8E5-9B9086F1A97C}"/>
              </a:ext>
            </a:extLst>
          </p:cNvPr>
          <p:cNvSpPr/>
          <p:nvPr/>
        </p:nvSpPr>
        <p:spPr>
          <a:xfrm rot="506968">
            <a:off x="6009815" y="944305"/>
            <a:ext cx="1790852" cy="262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4E5EB654-FB4A-4310-A6A2-45AA1B187894}"/>
              </a:ext>
            </a:extLst>
          </p:cNvPr>
          <p:cNvSpPr/>
          <p:nvPr/>
        </p:nvSpPr>
        <p:spPr>
          <a:xfrm>
            <a:off x="6404890" y="3178791"/>
            <a:ext cx="1932994" cy="12018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40" name="文本框 2">
            <a:extLst>
              <a:ext uri="{FF2B5EF4-FFF2-40B4-BE49-F238E27FC236}">
                <a16:creationId xmlns:a16="http://schemas.microsoft.com/office/drawing/2014/main" id="{D4631D4F-17C7-4B99-A09E-9B18B96419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19798" y="490318"/>
            <a:ext cx="99229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buFont typeface="Arial" panose="020B0604020202020204" pitchFamily="34" charset="0"/>
              <a:buNone/>
            </a:pP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UCP1</a:t>
            </a:r>
          </a:p>
        </p:txBody>
      </p:sp>
      <p:sp>
        <p:nvSpPr>
          <p:cNvPr id="41" name="文本框 3">
            <a:extLst>
              <a:ext uri="{FF2B5EF4-FFF2-40B4-BE49-F238E27FC236}">
                <a16:creationId xmlns:a16="http://schemas.microsoft.com/office/drawing/2014/main" id="{01DA2B12-D3EC-4BCD-9873-E4CC0EC36A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0354" y="1576116"/>
            <a:ext cx="104627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buFont typeface="Arial" panose="020B0604020202020204" pitchFamily="34" charset="0"/>
              <a:buNone/>
            </a:pP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PGC-1</a:t>
            </a:r>
            <a:r>
              <a:rPr lang="el-GR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α</a:t>
            </a:r>
          </a:p>
        </p:txBody>
      </p:sp>
      <p:sp>
        <p:nvSpPr>
          <p:cNvPr id="42" name="文本框 8">
            <a:extLst>
              <a:ext uri="{FF2B5EF4-FFF2-40B4-BE49-F238E27FC236}">
                <a16:creationId xmlns:a16="http://schemas.microsoft.com/office/drawing/2014/main" id="{CFF1768C-336A-4414-9275-CB39EC5459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47560" y="3349098"/>
            <a:ext cx="109073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buFont typeface="Arial" panose="020B0604020202020204" pitchFamily="34" charset="0"/>
              <a:buNone/>
            </a:pP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UQCRC2</a:t>
            </a:r>
          </a:p>
        </p:txBody>
      </p:sp>
      <p:sp>
        <p:nvSpPr>
          <p:cNvPr id="43" name="文本框 7">
            <a:extLst>
              <a:ext uri="{FF2B5EF4-FFF2-40B4-BE49-F238E27FC236}">
                <a16:creationId xmlns:a16="http://schemas.microsoft.com/office/drawing/2014/main" id="{7BD40FAF-0162-41C4-BB40-A7C8D17ED8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7606" y="3055760"/>
            <a:ext cx="89068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buFont typeface="Arial" panose="020B0604020202020204" pitchFamily="34" charset="0"/>
              <a:buNone/>
            </a:pP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ATP5A</a:t>
            </a:r>
          </a:p>
        </p:txBody>
      </p:sp>
      <p:sp>
        <p:nvSpPr>
          <p:cNvPr id="44" name="文本框 9">
            <a:extLst>
              <a:ext uri="{FF2B5EF4-FFF2-40B4-BE49-F238E27FC236}">
                <a16:creationId xmlns:a16="http://schemas.microsoft.com/office/drawing/2014/main" id="{997356D5-EEF4-42F4-97D1-0AE587414E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51149" y="3662229"/>
            <a:ext cx="8462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buFont typeface="Arial" panose="020B0604020202020204" pitchFamily="34" charset="0"/>
              <a:buNone/>
            </a:pP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SDHB</a:t>
            </a: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D477F887-C1B9-4079-8AD5-AF83967128B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79" t="63616" r="21806" b="10811"/>
          <a:stretch/>
        </p:blipFill>
        <p:spPr>
          <a:xfrm>
            <a:off x="5855195" y="5192208"/>
            <a:ext cx="3269988" cy="1469372"/>
          </a:xfrm>
          <a:prstGeom prst="rect">
            <a:avLst/>
          </a:prstGeom>
        </p:spPr>
      </p:pic>
      <p:sp>
        <p:nvSpPr>
          <p:cNvPr id="65" name="矩形 64">
            <a:extLst>
              <a:ext uri="{FF2B5EF4-FFF2-40B4-BE49-F238E27FC236}">
                <a16:creationId xmlns:a16="http://schemas.microsoft.com/office/drawing/2014/main" id="{8706D63F-FB6C-43F3-AE32-F9B53EF8D743}"/>
              </a:ext>
            </a:extLst>
          </p:cNvPr>
          <p:cNvSpPr/>
          <p:nvPr/>
        </p:nvSpPr>
        <p:spPr>
          <a:xfrm>
            <a:off x="6127679" y="5707526"/>
            <a:ext cx="1804209" cy="2786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66" name="文本框 4106">
            <a:extLst>
              <a:ext uri="{FF2B5EF4-FFF2-40B4-BE49-F238E27FC236}">
                <a16:creationId xmlns:a16="http://schemas.microsoft.com/office/drawing/2014/main" id="{7F77057C-3C14-4E75-8996-6F712DE1B8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55195" y="5155887"/>
            <a:ext cx="879756" cy="3385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sym typeface="等线" panose="02010600030101010101" pitchFamily="2" charset="-122"/>
              </a:rPr>
              <a:t>Actin</a:t>
            </a:r>
          </a:p>
        </p:txBody>
      </p:sp>
      <p:pic>
        <p:nvPicPr>
          <p:cNvPr id="67" name="图片 13">
            <a:extLst>
              <a:ext uri="{FF2B5EF4-FFF2-40B4-BE49-F238E27FC236}">
                <a16:creationId xmlns:a16="http://schemas.microsoft.com/office/drawing/2014/main" id="{3B614C17-1F38-4080-BE70-0F781B2E4B5E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 bwMode="auto">
          <a:xfrm>
            <a:off x="6023768" y="2112563"/>
            <a:ext cx="2695238" cy="314286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8" name="矩形 67">
            <a:extLst>
              <a:ext uri="{FF2B5EF4-FFF2-40B4-BE49-F238E27FC236}">
                <a16:creationId xmlns:a16="http://schemas.microsoft.com/office/drawing/2014/main" id="{0A2E9CA9-106E-40EE-B89A-A81235AAE3AC}"/>
              </a:ext>
            </a:extLst>
          </p:cNvPr>
          <p:cNvSpPr/>
          <p:nvPr/>
        </p:nvSpPr>
        <p:spPr>
          <a:xfrm>
            <a:off x="6052149" y="2131505"/>
            <a:ext cx="1676128" cy="2984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976DE212-AF39-4C52-82C3-B66140676B79}"/>
              </a:ext>
            </a:extLst>
          </p:cNvPr>
          <p:cNvGrpSpPr/>
          <p:nvPr/>
        </p:nvGrpSpPr>
        <p:grpSpPr>
          <a:xfrm>
            <a:off x="813743" y="1889309"/>
            <a:ext cx="3112081" cy="2415166"/>
            <a:chOff x="813743" y="1889309"/>
            <a:chExt cx="3112081" cy="2415166"/>
          </a:xfrm>
        </p:grpSpPr>
        <p:sp>
          <p:nvSpPr>
            <p:cNvPr id="50" name="文本框 4104">
              <a:extLst>
                <a:ext uri="{FF2B5EF4-FFF2-40B4-BE49-F238E27FC236}">
                  <a16:creationId xmlns:a16="http://schemas.microsoft.com/office/drawing/2014/main" id="{ECCA4D7D-EC6C-48D8-A8FA-AED0A3242F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04405" y="1889309"/>
              <a:ext cx="7245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sym typeface="等线" panose="02010600030101010101" pitchFamily="2" charset="-122"/>
                </a:rPr>
                <a:t>UCP1</a:t>
              </a:r>
            </a:p>
          </p:txBody>
        </p:sp>
        <p:sp>
          <p:nvSpPr>
            <p:cNvPr id="51" name="文本框 4114">
              <a:extLst>
                <a:ext uri="{FF2B5EF4-FFF2-40B4-BE49-F238E27FC236}">
                  <a16:creationId xmlns:a16="http://schemas.microsoft.com/office/drawing/2014/main" id="{051712B6-FC5F-42A1-9A65-D9BB0B5DF8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21579" y="2163659"/>
              <a:ext cx="122147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sym typeface="等线" panose="02010600030101010101" pitchFamily="2" charset="-122"/>
                </a:rPr>
                <a:t>PGC-1</a:t>
              </a:r>
              <a:r>
                <a:rPr lang="el-GR" altLang="zh-CN" sz="1400" b="1" dirty="0">
                  <a:latin typeface="Arial" panose="020B0604020202020204" pitchFamily="34" charset="0"/>
                  <a:ea typeface="等线" panose="02010600030101010101" pitchFamily="2" charset="-122"/>
                  <a:sym typeface="等线" panose="02010600030101010101" pitchFamily="2" charset="-122"/>
                </a:rPr>
                <a:t>α</a:t>
              </a:r>
            </a:p>
          </p:txBody>
        </p:sp>
        <p:sp>
          <p:nvSpPr>
            <p:cNvPr id="52" name="文本框 4106">
              <a:extLst>
                <a:ext uri="{FF2B5EF4-FFF2-40B4-BE49-F238E27FC236}">
                  <a16:creationId xmlns:a16="http://schemas.microsoft.com/office/drawing/2014/main" id="{9821E1BC-24AD-471F-B463-EDE85B7E31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7790" y="3461369"/>
              <a:ext cx="88009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sym typeface="等线" panose="02010600030101010101" pitchFamily="2" charset="-122"/>
                </a:rPr>
                <a:t>Actin</a:t>
              </a:r>
            </a:p>
          </p:txBody>
        </p:sp>
        <p:pic>
          <p:nvPicPr>
            <p:cNvPr id="60" name="图片 10">
              <a:extLst>
                <a:ext uri="{FF2B5EF4-FFF2-40B4-BE49-F238E27FC236}">
                  <a16:creationId xmlns:a16="http://schemas.microsoft.com/office/drawing/2014/main" id="{79D7C6BB-F14D-4730-8256-6703513B017B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6">
              <a:lum bright="14000" contrast="28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241" b="16467"/>
            <a:stretch>
              <a:fillRect/>
            </a:stretch>
          </p:blipFill>
          <p:spPr bwMode="auto">
            <a:xfrm>
              <a:off x="1778676" y="1903593"/>
              <a:ext cx="1980000" cy="2376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" name="图片 11">
              <a:extLst>
                <a:ext uri="{FF2B5EF4-FFF2-40B4-BE49-F238E27FC236}">
                  <a16:creationId xmlns:a16="http://schemas.microsoft.com/office/drawing/2014/main" id="{AA2BA1DF-D8E4-4FE4-BF29-0B3501277B4B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7">
              <a:lum bright="52000" contrast="62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7" r="33409" b="5835"/>
            <a:stretch>
              <a:fillRect/>
            </a:stretch>
          </p:blipFill>
          <p:spPr bwMode="auto">
            <a:xfrm>
              <a:off x="1771067" y="3496291"/>
              <a:ext cx="1980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2" name="图片 13">
              <a:extLst>
                <a:ext uri="{FF2B5EF4-FFF2-40B4-BE49-F238E27FC236}">
                  <a16:creationId xmlns:a16="http://schemas.microsoft.com/office/drawing/2014/main" id="{84C1243A-02EC-492E-BA7E-B3E3DFD0CFF2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5">
              <a:lum bright="12000" contrast="66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218" b="18588"/>
            <a:stretch>
              <a:fillRect/>
            </a:stretch>
          </p:blipFill>
          <p:spPr bwMode="auto">
            <a:xfrm>
              <a:off x="1778676" y="2199334"/>
              <a:ext cx="1980000" cy="2376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3" name="Picture 24">
              <a:extLst>
                <a:ext uri="{FF2B5EF4-FFF2-40B4-BE49-F238E27FC236}">
                  <a16:creationId xmlns:a16="http://schemas.microsoft.com/office/drawing/2014/main" id="{5827CEDD-AA89-4C9C-B144-3EA93368145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272"/>
            <a:stretch>
              <a:fillRect/>
            </a:stretch>
          </p:blipFill>
          <p:spPr bwMode="auto">
            <a:xfrm>
              <a:off x="1771067" y="2500350"/>
              <a:ext cx="1980000" cy="9366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7" name="TextBox 54">
              <a:extLst>
                <a:ext uri="{FF2B5EF4-FFF2-40B4-BE49-F238E27FC236}">
                  <a16:creationId xmlns:a16="http://schemas.microsoft.com/office/drawing/2014/main" id="{B3C8265B-5B70-4530-9498-6957C492D2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8107" y="2453821"/>
              <a:ext cx="90063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sym typeface="等线" panose="02010600030101010101" pitchFamily="2" charset="-122"/>
                </a:rPr>
                <a:t>ATP5A</a:t>
              </a:r>
            </a:p>
          </p:txBody>
        </p:sp>
        <p:sp>
          <p:nvSpPr>
            <p:cNvPr id="58" name="TextBox 55">
              <a:extLst>
                <a:ext uri="{FF2B5EF4-FFF2-40B4-BE49-F238E27FC236}">
                  <a16:creationId xmlns:a16="http://schemas.microsoft.com/office/drawing/2014/main" id="{A2E6319E-5A5A-4B28-B94A-4FDF6561260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3743" y="2651991"/>
              <a:ext cx="104629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sym typeface="等线" panose="02010600030101010101" pitchFamily="2" charset="-122"/>
                </a:rPr>
                <a:t>UQCRC2</a:t>
              </a:r>
            </a:p>
          </p:txBody>
        </p:sp>
        <p:sp>
          <p:nvSpPr>
            <p:cNvPr id="59" name="TextBox 57">
              <a:extLst>
                <a:ext uri="{FF2B5EF4-FFF2-40B4-BE49-F238E27FC236}">
                  <a16:creationId xmlns:a16="http://schemas.microsoft.com/office/drawing/2014/main" id="{9C3049A4-56DB-4142-A91A-6B2804A021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81082" y="2832546"/>
              <a:ext cx="83143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sym typeface="等线" panose="02010600030101010101" pitchFamily="2" charset="-122"/>
                </a:rPr>
                <a:t>SDHB</a:t>
              </a:r>
            </a:p>
          </p:txBody>
        </p:sp>
        <p:sp>
          <p:nvSpPr>
            <p:cNvPr id="85" name="TextBox 57">
              <a:extLst>
                <a:ext uri="{FF2B5EF4-FFF2-40B4-BE49-F238E27FC236}">
                  <a16:creationId xmlns:a16="http://schemas.microsoft.com/office/drawing/2014/main" id="{75E9EC64-3B88-46DF-8930-98689B730A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51241" y="3141442"/>
              <a:ext cx="971295" cy="3077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5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4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3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NDUFB8</a:t>
              </a:r>
            </a:p>
          </p:txBody>
        </p:sp>
        <p:sp>
          <p:nvSpPr>
            <p:cNvPr id="86" name="文本框 4107">
              <a:extLst>
                <a:ext uri="{FF2B5EF4-FFF2-40B4-BE49-F238E27FC236}">
                  <a16:creationId xmlns:a16="http://schemas.microsoft.com/office/drawing/2014/main" id="{79C31BD0-A7B5-4658-BAC9-D218D2E08A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38150" y="3781355"/>
              <a:ext cx="1168124" cy="523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5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4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3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1439863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    </a:t>
              </a: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r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+Vehicle</a:t>
              </a:r>
            </a:p>
          </p:txBody>
        </p:sp>
        <p:cxnSp>
          <p:nvCxnSpPr>
            <p:cNvPr id="87" name="直接连接符 14">
              <a:extLst>
                <a:ext uri="{FF2B5EF4-FFF2-40B4-BE49-F238E27FC236}">
                  <a16:creationId xmlns:a16="http://schemas.microsoft.com/office/drawing/2014/main" id="{541257DC-9508-4F31-B84A-96265742418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1824609" y="3815555"/>
              <a:ext cx="900163" cy="2654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8" name="直接连接符 15">
              <a:extLst>
                <a:ext uri="{FF2B5EF4-FFF2-40B4-BE49-F238E27FC236}">
                  <a16:creationId xmlns:a16="http://schemas.microsoft.com/office/drawing/2014/main" id="{EA5D63A3-129B-4A5C-BF1E-8D99E0C8599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846586" y="3817465"/>
              <a:ext cx="900163" cy="2654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9" name="文本框 106">
              <a:extLst>
                <a:ext uri="{FF2B5EF4-FFF2-40B4-BE49-F238E27FC236}">
                  <a16:creationId xmlns:a16="http://schemas.microsoft.com/office/drawing/2014/main" id="{CE351F3A-5376-4D8A-B9CE-15B3C7C139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01874" y="3782188"/>
              <a:ext cx="1123950" cy="522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 </a:t>
              </a: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r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endParaRPr lang="en-US" altLang="zh-CN" sz="14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等线" panose="02010600030101010101" pitchFamily="2" charset="-122"/>
                </a:rPr>
                <a:t>+Ang-(1-7) 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1" name="TextBox 57">
            <a:extLst>
              <a:ext uri="{FF2B5EF4-FFF2-40B4-BE49-F238E27FC236}">
                <a16:creationId xmlns:a16="http://schemas.microsoft.com/office/drawing/2014/main" id="{CFBC4193-16C5-44B1-AD26-F4308857A0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7205" y="3967607"/>
            <a:ext cx="971295" cy="3077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4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3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43986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43986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43986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43986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NDUFB8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8">
            <a:extLst>
              <a:ext uri="{FF2B5EF4-FFF2-40B4-BE49-F238E27FC236}">
                <a16:creationId xmlns:a16="http://schemas.microsoft.com/office/drawing/2014/main" id="{D062A432-18D5-4704-9E8F-2615A0E7C1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3" y="777875"/>
            <a:ext cx="577850" cy="398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000" b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8195" name="TextBox 47">
            <a:extLst>
              <a:ext uri="{FF2B5EF4-FFF2-40B4-BE49-F238E27FC236}">
                <a16:creationId xmlns:a16="http://schemas.microsoft.com/office/drawing/2014/main" id="{3B5B8616-C452-4785-B0E8-2BB46C926A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76313" y="1058863"/>
            <a:ext cx="2587625" cy="309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FD+NaCl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FD+Ang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(1-7)   </a:t>
            </a: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653863B8-C5BB-4795-9359-1940F33E4F37}"/>
              </a:ext>
            </a:extLst>
          </p:cNvPr>
          <p:cNvCxnSpPr/>
          <p:nvPr/>
        </p:nvCxnSpPr>
        <p:spPr bwMode="auto">
          <a:xfrm>
            <a:off x="1176338" y="1379538"/>
            <a:ext cx="8699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97" name="图片 45" descr="2017-12-20 ucp1 1~7bat zyc 0.tif">
            <a:extLst>
              <a:ext uri="{FF2B5EF4-FFF2-40B4-BE49-F238E27FC236}">
                <a16:creationId xmlns:a16="http://schemas.microsoft.com/office/drawing/2014/main" id="{3E696060-A84E-43C9-9CCB-52D718B276EB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9350" y="1514475"/>
            <a:ext cx="3230563" cy="3127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198" name="文本框 22">
            <a:extLst>
              <a:ext uri="{FF2B5EF4-FFF2-40B4-BE49-F238E27FC236}">
                <a16:creationId xmlns:a16="http://schemas.microsoft.com/office/drawing/2014/main" id="{FEB94BD0-558B-4FC1-8748-4A95DAC0AB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613" y="1487488"/>
            <a:ext cx="754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pic>
        <p:nvPicPr>
          <p:cNvPr id="8199" name="Picture 2">
            <a:extLst>
              <a:ext uri="{FF2B5EF4-FFF2-40B4-BE49-F238E27FC236}">
                <a16:creationId xmlns:a16="http://schemas.microsoft.com/office/drawing/2014/main" id="{4EE66E22-7D7B-4227-B5CA-E47E8C4F3CF8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175" y="2168525"/>
            <a:ext cx="3241675" cy="2889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3">
            <a:extLst>
              <a:ext uri="{FF2B5EF4-FFF2-40B4-BE49-F238E27FC236}">
                <a16:creationId xmlns:a16="http://schemas.microsoft.com/office/drawing/2014/main" id="{4B30E1B4-1F42-4CEC-8E18-03461500E8EC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175" y="2492375"/>
            <a:ext cx="3241675" cy="287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1" name="Picture 4">
            <a:extLst>
              <a:ext uri="{FF2B5EF4-FFF2-40B4-BE49-F238E27FC236}">
                <a16:creationId xmlns:a16="http://schemas.microsoft.com/office/drawing/2014/main" id="{E4F6D792-2828-4A49-B7CC-18BC96E100A5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175" y="2814638"/>
            <a:ext cx="3241675" cy="2873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2" name="Picture 5">
            <a:extLst>
              <a:ext uri="{FF2B5EF4-FFF2-40B4-BE49-F238E27FC236}">
                <a16:creationId xmlns:a16="http://schemas.microsoft.com/office/drawing/2014/main" id="{71E2F783-7682-4ADF-A411-966E88326B25}"/>
              </a:ext>
            </a:extLst>
          </p:cNvPr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175" y="3136900"/>
            <a:ext cx="3241675" cy="287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3" name="Picture 13">
            <a:extLst>
              <a:ext uri="{FF2B5EF4-FFF2-40B4-BE49-F238E27FC236}">
                <a16:creationId xmlns:a16="http://schemas.microsoft.com/office/drawing/2014/main" id="{16B7A2A4-E67F-46CB-A6EA-8EFF79142D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1413" y="3454400"/>
            <a:ext cx="3241675" cy="2635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204" name="文本框 22">
            <a:extLst>
              <a:ext uri="{FF2B5EF4-FFF2-40B4-BE49-F238E27FC236}">
                <a16:creationId xmlns:a16="http://schemas.microsoft.com/office/drawing/2014/main" id="{58947B52-C81F-451A-8D86-F406C50F25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575" y="1874838"/>
            <a:ext cx="846138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GC-1</a:t>
            </a:r>
            <a:r>
              <a:rPr lang="el-GR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05" name="TextBox 54">
            <a:extLst>
              <a:ext uri="{FF2B5EF4-FFF2-40B4-BE49-F238E27FC236}">
                <a16:creationId xmlns:a16="http://schemas.microsoft.com/office/drawing/2014/main" id="{97065BE7-17A5-4128-861E-CBF5E4E22C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850" y="2193925"/>
            <a:ext cx="827088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TP5A</a:t>
            </a:r>
          </a:p>
        </p:txBody>
      </p:sp>
      <p:sp>
        <p:nvSpPr>
          <p:cNvPr id="8206" name="TextBox 55">
            <a:extLst>
              <a:ext uri="{FF2B5EF4-FFF2-40B4-BE49-F238E27FC236}">
                <a16:creationId xmlns:a16="http://schemas.microsoft.com/office/drawing/2014/main" id="{D3C95D7A-8114-489A-A701-7F972890BE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263" y="2519363"/>
            <a:ext cx="990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UQCRC2</a:t>
            </a:r>
          </a:p>
        </p:txBody>
      </p:sp>
      <p:sp>
        <p:nvSpPr>
          <p:cNvPr id="8207" name="TextBox 57">
            <a:extLst>
              <a:ext uri="{FF2B5EF4-FFF2-40B4-BE49-F238E27FC236}">
                <a16:creationId xmlns:a16="http://schemas.microsoft.com/office/drawing/2014/main" id="{3AC37E01-5837-4508-A34B-7451BB1D12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9575" y="2836863"/>
            <a:ext cx="7604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DHB</a:t>
            </a:r>
          </a:p>
        </p:txBody>
      </p:sp>
      <p:sp>
        <p:nvSpPr>
          <p:cNvPr id="8208" name="TextBox 58">
            <a:extLst>
              <a:ext uri="{FF2B5EF4-FFF2-40B4-BE49-F238E27FC236}">
                <a16:creationId xmlns:a16="http://schemas.microsoft.com/office/drawing/2014/main" id="{6AF646BE-65F1-47B3-901D-A700A0AEDD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488" y="3160713"/>
            <a:ext cx="904875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NDUFB8</a:t>
            </a:r>
          </a:p>
        </p:txBody>
      </p:sp>
      <p:sp>
        <p:nvSpPr>
          <p:cNvPr id="8209" name="TextBox 60">
            <a:extLst>
              <a:ext uri="{FF2B5EF4-FFF2-40B4-BE49-F238E27FC236}">
                <a16:creationId xmlns:a16="http://schemas.microsoft.com/office/drawing/2014/main" id="{AF07BAE6-A5B0-4532-B3B6-A9424C02F5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663" y="3467100"/>
            <a:ext cx="693737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8210" name="文本框 1">
            <a:extLst>
              <a:ext uri="{FF2B5EF4-FFF2-40B4-BE49-F238E27FC236}">
                <a16:creationId xmlns:a16="http://schemas.microsoft.com/office/drawing/2014/main" id="{DFAAA1F1-D937-4D6E-AFEC-2ED2BF4DDB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0550" y="911225"/>
            <a:ext cx="1792288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FD+Ang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(1-7)</a:t>
            </a:r>
          </a:p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 A779</a:t>
            </a: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AA848725-1019-4B57-8341-F08E8A0764CF}"/>
              </a:ext>
            </a:extLst>
          </p:cNvPr>
          <p:cNvCxnSpPr/>
          <p:nvPr/>
        </p:nvCxnSpPr>
        <p:spPr bwMode="auto">
          <a:xfrm>
            <a:off x="2317750" y="1379538"/>
            <a:ext cx="8699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4CDC880A-6F11-42F4-A60E-88D42216C061}"/>
              </a:ext>
            </a:extLst>
          </p:cNvPr>
          <p:cNvCxnSpPr/>
          <p:nvPr/>
        </p:nvCxnSpPr>
        <p:spPr bwMode="auto">
          <a:xfrm>
            <a:off x="3444875" y="1379538"/>
            <a:ext cx="8699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13" name="TextBox 10">
            <a:extLst>
              <a:ext uri="{FF2B5EF4-FFF2-40B4-BE49-F238E27FC236}">
                <a16:creationId xmlns:a16="http://schemas.microsoft.com/office/drawing/2014/main" id="{231D4DFA-8C71-4A59-8795-330513BB55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63" y="30163"/>
            <a:ext cx="1817687" cy="519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14" name="图片 4">
            <a:extLst>
              <a:ext uri="{FF2B5EF4-FFF2-40B4-BE49-F238E27FC236}">
                <a16:creationId xmlns:a16="http://schemas.microsoft.com/office/drawing/2014/main" id="{BDCF8A67-DE94-4164-8853-BB6E13D8188E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175" y="1852613"/>
            <a:ext cx="3240088" cy="2873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215" name="组合 51">
            <a:extLst>
              <a:ext uri="{FF2B5EF4-FFF2-40B4-BE49-F238E27FC236}">
                <a16:creationId xmlns:a16="http://schemas.microsoft.com/office/drawing/2014/main" id="{3E32F9BE-B77C-42EA-9E61-7367D68F2A49}"/>
              </a:ext>
            </a:extLst>
          </p:cNvPr>
          <p:cNvGrpSpPr>
            <a:grpSpLocks/>
          </p:cNvGrpSpPr>
          <p:nvPr/>
        </p:nvGrpSpPr>
        <p:grpSpPr bwMode="auto">
          <a:xfrm>
            <a:off x="5270500" y="30163"/>
            <a:ext cx="5353050" cy="6908800"/>
            <a:chOff x="5269709" y="29874"/>
            <a:chExt cx="5354053" cy="6908374"/>
          </a:xfrm>
        </p:grpSpPr>
        <p:pic>
          <p:nvPicPr>
            <p:cNvPr id="8223" name="图片 1">
              <a:extLst>
                <a:ext uri="{FF2B5EF4-FFF2-40B4-BE49-F238E27FC236}">
                  <a16:creationId xmlns:a16="http://schemas.microsoft.com/office/drawing/2014/main" id="{3080F9E0-B3EC-4C2B-9734-0BB43537964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082" t="51974" r="29877" b="32288"/>
            <a:stretch>
              <a:fillRect/>
            </a:stretch>
          </p:blipFill>
          <p:spPr bwMode="auto">
            <a:xfrm>
              <a:off x="5546036" y="29874"/>
              <a:ext cx="4352454" cy="1167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FA6E7B8E-BB14-493A-9E40-7067F0AB8E83}"/>
                </a:ext>
              </a:extLst>
            </p:cNvPr>
            <p:cNvSpPr/>
            <p:nvPr/>
          </p:nvSpPr>
          <p:spPr>
            <a:xfrm>
              <a:off x="6433565" y="371165"/>
              <a:ext cx="3070800" cy="43018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225" name="图片 2">
              <a:extLst>
                <a:ext uri="{FF2B5EF4-FFF2-40B4-BE49-F238E27FC236}">
                  <a16:creationId xmlns:a16="http://schemas.microsoft.com/office/drawing/2014/main" id="{064C3106-48A2-4A81-9033-BBD7C1F79F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0" t="57732" r="24197" b="22752"/>
            <a:stretch>
              <a:fillRect/>
            </a:stretch>
          </p:blipFill>
          <p:spPr bwMode="auto">
            <a:xfrm>
              <a:off x="5546036" y="1302530"/>
              <a:ext cx="4271210" cy="1327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C65C0EC3-0946-45EE-9C35-07ABDD8B5A7D}"/>
                </a:ext>
              </a:extLst>
            </p:cNvPr>
            <p:cNvSpPr/>
            <p:nvPr/>
          </p:nvSpPr>
          <p:spPr>
            <a:xfrm>
              <a:off x="6146173" y="1952217"/>
              <a:ext cx="2838982" cy="43336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227" name="图片 27">
              <a:extLst>
                <a:ext uri="{FF2B5EF4-FFF2-40B4-BE49-F238E27FC236}">
                  <a16:creationId xmlns:a16="http://schemas.microsoft.com/office/drawing/2014/main" id="{CCF5C11C-A3AF-44B3-B38A-B0CE6ADFFA3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70" t="29572" r="14784" b="36137"/>
            <a:stretch>
              <a:fillRect/>
            </a:stretch>
          </p:blipFill>
          <p:spPr bwMode="auto">
            <a:xfrm>
              <a:off x="5269709" y="2622106"/>
              <a:ext cx="5354053" cy="23220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A7E5A2AA-7E20-4DC8-8D42-C252C384B7CE}"/>
                </a:ext>
              </a:extLst>
            </p:cNvPr>
            <p:cNvSpPr/>
            <p:nvPr/>
          </p:nvSpPr>
          <p:spPr>
            <a:xfrm>
              <a:off x="5812736" y="3207853"/>
              <a:ext cx="3891692" cy="144612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229" name="图片 49">
              <a:extLst>
                <a:ext uri="{FF2B5EF4-FFF2-40B4-BE49-F238E27FC236}">
                  <a16:creationId xmlns:a16="http://schemas.microsoft.com/office/drawing/2014/main" id="{E2200598-C60E-4AAA-AB64-9C98D49ED8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02" t="21884" r="18187" b="41299"/>
            <a:stretch>
              <a:fillRect/>
            </a:stretch>
          </p:blipFill>
          <p:spPr bwMode="auto">
            <a:xfrm>
              <a:off x="5642288" y="4957011"/>
              <a:ext cx="4174958" cy="1981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F1BF5B3B-E9E6-4235-B7AC-E32F94764FA7}"/>
                </a:ext>
              </a:extLst>
            </p:cNvPr>
            <p:cNvSpPr/>
            <p:nvPr/>
          </p:nvSpPr>
          <p:spPr>
            <a:xfrm>
              <a:off x="6195395" y="6149309"/>
              <a:ext cx="3070800" cy="436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16" name="文本框 2">
            <a:extLst>
              <a:ext uri="{FF2B5EF4-FFF2-40B4-BE49-F238E27FC236}">
                <a16:creationId xmlns:a16="http://schemas.microsoft.com/office/drawing/2014/main" id="{6E36D304-7147-4C21-8A18-2FE3AEF046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8788" y="11113"/>
            <a:ext cx="99377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8217" name="文本框 3">
            <a:extLst>
              <a:ext uri="{FF2B5EF4-FFF2-40B4-BE49-F238E27FC236}">
                <a16:creationId xmlns:a16="http://schemas.microsoft.com/office/drawing/2014/main" id="{9C67BD0C-745C-4336-BEF2-6A8FBA2A49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0700" y="1414463"/>
            <a:ext cx="10461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GC-1</a:t>
            </a:r>
            <a:r>
              <a:rPr lang="el-GR" altLang="zh-CN" sz="16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</a:t>
            </a:r>
          </a:p>
        </p:txBody>
      </p:sp>
      <p:sp>
        <p:nvSpPr>
          <p:cNvPr id="8218" name="文本框 8">
            <a:extLst>
              <a:ext uri="{FF2B5EF4-FFF2-40B4-BE49-F238E27FC236}">
                <a16:creationId xmlns:a16="http://schemas.microsoft.com/office/drawing/2014/main" id="{E79589B3-A4AF-4354-A350-8531C5ECE4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3375" y="3476625"/>
            <a:ext cx="1090613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QCRC2</a:t>
            </a:r>
          </a:p>
        </p:txBody>
      </p:sp>
      <p:sp>
        <p:nvSpPr>
          <p:cNvPr id="8219" name="文本框 7">
            <a:extLst>
              <a:ext uri="{FF2B5EF4-FFF2-40B4-BE49-F238E27FC236}">
                <a16:creationId xmlns:a16="http://schemas.microsoft.com/office/drawing/2014/main" id="{134C5E72-0F3F-4B62-AABC-0D2AE84F7A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37213" y="3170238"/>
            <a:ext cx="8905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TP5A</a:t>
            </a:r>
          </a:p>
        </p:txBody>
      </p:sp>
      <p:sp>
        <p:nvSpPr>
          <p:cNvPr id="8220" name="文本框 9">
            <a:extLst>
              <a:ext uri="{FF2B5EF4-FFF2-40B4-BE49-F238E27FC236}">
                <a16:creationId xmlns:a16="http://schemas.microsoft.com/office/drawing/2014/main" id="{CB22C58B-7DE1-4029-B327-36B9CCC618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4838" y="3886200"/>
            <a:ext cx="8477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DHB</a:t>
            </a:r>
          </a:p>
        </p:txBody>
      </p:sp>
      <p:sp>
        <p:nvSpPr>
          <p:cNvPr id="8221" name="TextBox 58">
            <a:extLst>
              <a:ext uri="{FF2B5EF4-FFF2-40B4-BE49-F238E27FC236}">
                <a16:creationId xmlns:a16="http://schemas.microsoft.com/office/drawing/2014/main" id="{1AC9B70F-2420-4C88-A0D1-26D8B50D11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2925" y="4159250"/>
            <a:ext cx="90487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NDUFB8</a:t>
            </a:r>
          </a:p>
        </p:txBody>
      </p:sp>
      <p:sp>
        <p:nvSpPr>
          <p:cNvPr id="8222" name="TextBox 60">
            <a:extLst>
              <a:ext uri="{FF2B5EF4-FFF2-40B4-BE49-F238E27FC236}">
                <a16:creationId xmlns:a16="http://schemas.microsoft.com/office/drawing/2014/main" id="{68C3D5A8-AC97-4739-8EFF-C9DF4C4EA0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3063" y="6242050"/>
            <a:ext cx="693737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71</Words>
  <Application>Microsoft Office PowerPoint</Application>
  <PresentationFormat>宽屏</PresentationFormat>
  <Paragraphs>3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8</dc:creator>
  <cp:lastModifiedBy>258</cp:lastModifiedBy>
  <cp:revision>4</cp:revision>
  <dcterms:created xsi:type="dcterms:W3CDTF">2021-08-06T13:18:49Z</dcterms:created>
  <dcterms:modified xsi:type="dcterms:W3CDTF">2022-02-06T05:02:59Z</dcterms:modified>
</cp:coreProperties>
</file>